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7051675" cy="93091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52400" cy="9309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3056040" cy="465120"/>
          </a:xfrm>
          <a:prstGeom prst="rect">
            <a:avLst/>
          </a:prstGeom>
          <a:noFill/>
          <a:ln w="0">
            <a:noFill/>
          </a:ln>
        </p:spPr>
        <p:txBody>
          <a:bodyPr lIns="93600" rIns="936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95280" y="0"/>
            <a:ext cx="3056040" cy="465120"/>
          </a:xfrm>
          <a:prstGeom prst="rect">
            <a:avLst/>
          </a:prstGeom>
          <a:noFill/>
          <a:ln w="0">
            <a:noFill/>
          </a:ln>
        </p:spPr>
        <p:txBody>
          <a:bodyPr lIns="93600" rIns="936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99880" y="698040"/>
            <a:ext cx="4654440" cy="34909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3600" rIns="936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4880" y="4420800"/>
            <a:ext cx="5643360" cy="4189320"/>
          </a:xfrm>
          <a:prstGeom prst="rect">
            <a:avLst/>
          </a:prstGeom>
          <a:noFill/>
          <a:ln w="0">
            <a:noFill/>
          </a:ln>
        </p:spPr>
        <p:txBody>
          <a:bodyPr lIns="93600" rIns="936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842320"/>
            <a:ext cx="3056040" cy="465120"/>
          </a:xfrm>
          <a:prstGeom prst="rect">
            <a:avLst/>
          </a:prstGeom>
          <a:noFill/>
          <a:ln w="0">
            <a:noFill/>
          </a:ln>
        </p:spPr>
        <p:txBody>
          <a:bodyPr lIns="93600" rIns="936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95280" y="8842320"/>
            <a:ext cx="3056040" cy="465120"/>
          </a:xfrm>
          <a:prstGeom prst="rect">
            <a:avLst/>
          </a:prstGeom>
          <a:noFill/>
          <a:ln w="0">
            <a:noFill/>
          </a:ln>
        </p:spPr>
        <p:txBody>
          <a:bodyPr lIns="93600" rIns="936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DD527C-073A-4DE3-9969-75E2EB06445D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sldImg"/>
          </p:nvPr>
        </p:nvSpPr>
        <p:spPr>
          <a:xfrm>
            <a:off x="1200240" y="698400"/>
            <a:ext cx="4654440" cy="3490920"/>
          </a:xfrm>
          <a:prstGeom prst="rect">
            <a:avLst/>
          </a:prstGeom>
          <a:ln w="0">
            <a:noFill/>
          </a:ln>
        </p:spPr>
      </p:sp>
      <p:sp>
        <p:nvSpPr>
          <p:cNvPr id="66" name="PlaceHolder 2"/>
          <p:cNvSpPr>
            <a:spLocks noGrp="1"/>
          </p:cNvSpPr>
          <p:nvPr>
            <p:ph type="body"/>
          </p:nvPr>
        </p:nvSpPr>
        <p:spPr>
          <a:xfrm>
            <a:off x="704880" y="4420800"/>
            <a:ext cx="5643360" cy="4189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Slide Number Placeholder 3"/>
          <p:cNvSpPr/>
          <p:nvPr/>
        </p:nvSpPr>
        <p:spPr>
          <a:xfrm>
            <a:off x="3995640" y="8842320"/>
            <a:ext cx="305604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600" rIns="936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7F8E28D-788F-4743-8033-0FA8616E28E2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42E97B-4EAB-4C2A-B0A6-7445C5EE7B8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74B54C-EE92-4972-91BD-4C3E612498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D86379-F94F-4C38-AE93-65DB4452F97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F0C1DA-5393-43A0-A3E5-AED01D8F5AB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3AD79D-57F3-446C-950B-20C8E7816E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8CD81C-D21F-4287-A3D8-5DF3B25943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00E776-C594-428B-8FC3-62A1F470DC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8D0488-C0B3-4766-84CE-6C5BEEFCA8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1AB837-FA7F-4910-8646-9B9D24D664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579707-6C93-4E5F-9C91-380A68DA6C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BF8678-5638-47B3-AFAB-D6BBB4DD76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80CDA0-DC83-4138-8D46-2D09D548DF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6296FE2-E157-4431-961E-A0B176363DD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"/>
          <p:cNvSpPr/>
          <p:nvPr/>
        </p:nvSpPr>
        <p:spPr>
          <a:xfrm>
            <a:off x="3203640" y="336600"/>
            <a:ext cx="52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K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2"/>
          <p:cNvSpPr/>
          <p:nvPr/>
        </p:nvSpPr>
        <p:spPr>
          <a:xfrm>
            <a:off x="1676520" y="1357200"/>
            <a:ext cx="736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H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3"/>
          <p:cNvSpPr/>
          <p:nvPr/>
        </p:nvSpPr>
        <p:spPr>
          <a:xfrm>
            <a:off x="1517760" y="3108240"/>
            <a:ext cx="782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K19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4"/>
          <p:cNvSpPr/>
          <p:nvPr/>
        </p:nvSpPr>
        <p:spPr>
          <a:xfrm>
            <a:off x="5490000" y="336600"/>
            <a:ext cx="964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KT/Jag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Picture 7" descr=""/>
          <p:cNvPicPr/>
          <p:nvPr/>
        </p:nvPicPr>
        <p:blipFill>
          <a:blip r:embed="rId1"/>
          <a:stretch/>
        </p:blipFill>
        <p:spPr>
          <a:xfrm>
            <a:off x="4746600" y="2508120"/>
            <a:ext cx="2511360" cy="1797120"/>
          </a:xfrm>
          <a:prstGeom prst="rect">
            <a:avLst/>
          </a:prstGeom>
          <a:ln w="0">
            <a:noFill/>
          </a:ln>
        </p:spPr>
      </p:pic>
      <p:sp>
        <p:nvSpPr>
          <p:cNvPr id="53" name="TextBox 5"/>
          <p:cNvSpPr/>
          <p:nvPr/>
        </p:nvSpPr>
        <p:spPr>
          <a:xfrm>
            <a:off x="228600" y="4692600"/>
            <a:ext cx="8686800" cy="169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. CK19(+) ductal-like cells can be found in AKT/Jag1 premalignant lesions. 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H&amp;E (upper) and CK19 IHC images (lower) of AKT only or AKT/Jag1  injected mouse liver at 8 weeks post injection. CK19(+) cells can only be found in normal ducts (inset, left lower panel) of AKT only injected liver tissues. In striking contrast, CK19(+) ductal-like cells (inset, right lower panel) can be observed throughout the liver of AKT/Jag1 injected liver tissues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Picture 6" descr=""/>
          <p:cNvPicPr/>
          <p:nvPr/>
        </p:nvPicPr>
        <p:blipFill>
          <a:blip r:embed="rId2"/>
          <a:stretch/>
        </p:blipFill>
        <p:spPr>
          <a:xfrm>
            <a:off x="4746600" y="623880"/>
            <a:ext cx="2511360" cy="179712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7" descr=""/>
          <p:cNvPicPr/>
          <p:nvPr/>
        </p:nvPicPr>
        <p:blipFill>
          <a:blip r:embed="rId3"/>
          <a:stretch/>
        </p:blipFill>
        <p:spPr>
          <a:xfrm>
            <a:off x="2155680" y="623880"/>
            <a:ext cx="2509920" cy="179712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8" descr=""/>
          <p:cNvPicPr/>
          <p:nvPr/>
        </p:nvPicPr>
        <p:blipFill>
          <a:blip r:embed="rId4"/>
          <a:stretch/>
        </p:blipFill>
        <p:spPr>
          <a:xfrm>
            <a:off x="2155680" y="2508120"/>
            <a:ext cx="2511720" cy="1797120"/>
          </a:xfrm>
          <a:prstGeom prst="rect">
            <a:avLst/>
          </a:prstGeom>
          <a:ln w="0">
            <a:noFill/>
          </a:ln>
        </p:spPr>
      </p:pic>
      <p:sp>
        <p:nvSpPr>
          <p:cNvPr id="57" name="Rectangle 6"/>
          <p:cNvSpPr/>
          <p:nvPr/>
        </p:nvSpPr>
        <p:spPr>
          <a:xfrm>
            <a:off x="3925800" y="2865600"/>
            <a:ext cx="265320" cy="2286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ctangle 16"/>
          <p:cNvSpPr/>
          <p:nvPr/>
        </p:nvSpPr>
        <p:spPr>
          <a:xfrm>
            <a:off x="6240600" y="2979720"/>
            <a:ext cx="264960" cy="2286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9" name="Group 14"/>
          <p:cNvGrpSpPr/>
          <p:nvPr/>
        </p:nvGrpSpPr>
        <p:grpSpPr>
          <a:xfrm>
            <a:off x="2155680" y="3621240"/>
            <a:ext cx="914400" cy="684000"/>
            <a:chOff x="2155680" y="3621240"/>
            <a:chExt cx="914400" cy="684000"/>
          </a:xfrm>
        </p:grpSpPr>
        <p:pic>
          <p:nvPicPr>
            <p:cNvPr id="60" name="Picture 7" descr=""/>
            <p:cNvPicPr/>
            <p:nvPr/>
          </p:nvPicPr>
          <p:blipFill>
            <a:blip r:embed="rId5"/>
            <a:stretch/>
          </p:blipFill>
          <p:spPr>
            <a:xfrm>
              <a:off x="2155680" y="3621240"/>
              <a:ext cx="914400" cy="684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" name="Rectangle 12"/>
            <p:cNvSpPr/>
            <p:nvPr/>
          </p:nvSpPr>
          <p:spPr>
            <a:xfrm>
              <a:off x="2155680" y="3621240"/>
              <a:ext cx="914400" cy="6840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2" name="Group 18"/>
          <p:cNvGrpSpPr/>
          <p:nvPr/>
        </p:nvGrpSpPr>
        <p:grpSpPr>
          <a:xfrm>
            <a:off x="4746600" y="3624120"/>
            <a:ext cx="914400" cy="681120"/>
            <a:chOff x="4746600" y="3624120"/>
            <a:chExt cx="914400" cy="681120"/>
          </a:xfrm>
        </p:grpSpPr>
        <p:pic>
          <p:nvPicPr>
            <p:cNvPr id="63" name="Picture 15" descr=""/>
            <p:cNvPicPr/>
            <p:nvPr/>
          </p:nvPicPr>
          <p:blipFill>
            <a:blip r:embed="rId6"/>
            <a:stretch/>
          </p:blipFill>
          <p:spPr>
            <a:xfrm>
              <a:off x="4746600" y="3624120"/>
              <a:ext cx="914400" cy="681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4" name="Rectangle 17"/>
            <p:cNvSpPr/>
            <p:nvPr/>
          </p:nvSpPr>
          <p:spPr>
            <a:xfrm>
              <a:off x="4746600" y="3624120"/>
              <a:ext cx="914400" cy="6811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6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li che</dc:creator>
  <dc:description/>
  <dc:language>en-US</dc:language>
  <cp:lastModifiedBy>xin chen lab</cp:lastModifiedBy>
  <cp:lastPrinted>2016-07-15T00:57:45Z</cp:lastPrinted>
  <dcterms:modified xsi:type="dcterms:W3CDTF">2016-07-25T19:26:34Z</dcterms:modified>
  <cp:revision>189</cp:revision>
  <dc:subject/>
  <dc:title>AKT+JAG1</dc:title>
</cp:coreProperties>
</file>